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2814" autoAdjust="0"/>
  </p:normalViewPr>
  <p:slideViewPr>
    <p:cSldViewPr>
      <p:cViewPr varScale="1">
        <p:scale>
          <a:sx n="86" d="100"/>
          <a:sy n="86" d="100"/>
        </p:scale>
        <p:origin x="3186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13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18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5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96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936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666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885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62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535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78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11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506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5734993"/>
              </p:ext>
            </p:extLst>
          </p:nvPr>
        </p:nvGraphicFramePr>
        <p:xfrm>
          <a:off x="304799" y="152400"/>
          <a:ext cx="3108766" cy="27908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9" name="SPW 13.0 Graph" r:id="rId3" imgW="5789735" imgH="5198201" progId="SigmaPlotGraphicObject.12">
                  <p:embed/>
                </p:oleObj>
              </mc:Choice>
              <mc:Fallback>
                <p:oleObj name="SPW 13.0 Graph" r:id="rId3" imgW="5789735" imgH="5198201" progId="SigmaPlotGraphicObject.12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4799" y="152400"/>
                        <a:ext cx="3108766" cy="279081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3852154"/>
              </p:ext>
            </p:extLst>
          </p:nvPr>
        </p:nvGraphicFramePr>
        <p:xfrm>
          <a:off x="3348037" y="810399"/>
          <a:ext cx="3087456" cy="2133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0" name="SPW 13.0 Graph" r:id="rId5" imgW="5750052" imgH="3973062" progId="SigmaPlotGraphicObject.12">
                  <p:embed/>
                </p:oleObj>
              </mc:Choice>
              <mc:Fallback>
                <p:oleObj name="SPW 13.0 Graph" r:id="rId5" imgW="5750052" imgH="3973062" progId="SigmaPlotGraphicObject.12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48037" y="810399"/>
                        <a:ext cx="3087456" cy="21336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7567772"/>
              </p:ext>
            </p:extLst>
          </p:nvPr>
        </p:nvGraphicFramePr>
        <p:xfrm>
          <a:off x="347074" y="3506690"/>
          <a:ext cx="2641642" cy="26655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1" name="SPW 13.0 Graph" r:id="rId7" imgW="4915080" imgH="4962920" progId="SigmaPlotGraphicObject.12">
                  <p:embed/>
                </p:oleObj>
              </mc:Choice>
              <mc:Fallback>
                <p:oleObj name="SPW 13.0 Graph" r:id="rId7" imgW="4915080" imgH="4962920" progId="SigmaPlotGraphicObject.12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7074" y="3506690"/>
                        <a:ext cx="2641642" cy="26655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04800" y="5334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76600" y="5334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0978" y="32004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60635" y="5943600"/>
            <a:ext cx="552720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Fig. Effect of adipose-specific reductions in ATX on liver gene expression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expression in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dark bars) and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ipoq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Δ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open bars) male mice (n =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). 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233337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5</TotalTime>
  <Words>39</Words>
  <Application>Microsoft Office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SPW 13.0 Graph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yth, Susan</dc:creator>
  <cp:lastModifiedBy>McMullen, Colleen</cp:lastModifiedBy>
  <cp:revision>15</cp:revision>
  <cp:lastPrinted>2018-10-21T18:40:01Z</cp:lastPrinted>
  <dcterms:created xsi:type="dcterms:W3CDTF">2018-10-08T19:40:09Z</dcterms:created>
  <dcterms:modified xsi:type="dcterms:W3CDTF">2018-11-15T15:14:48Z</dcterms:modified>
</cp:coreProperties>
</file>